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3344" y="-4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947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889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965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737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766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25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086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510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457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546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26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62532-734D-4E4A-8728-28E81098180E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684BA0-A1A4-BC4C-A5B4-B860E8081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391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S3 Fil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b="1" dirty="0"/>
              <a:t>The quality of assembled sequences as a function of sequencing depth for </a:t>
            </a:r>
            <a:r>
              <a:rPr lang="en-US" sz="1400" b="1" dirty="0" smtClean="0"/>
              <a:t>all Illumina assemblies.</a:t>
            </a:r>
            <a:r>
              <a:rPr lang="en-US" sz="1400" dirty="0" smtClean="0"/>
              <a:t>  </a:t>
            </a:r>
            <a:r>
              <a:rPr lang="en-US" sz="1400" dirty="0"/>
              <a:t>The units for “Assembly Quality” are Normalized Bit Score (BS, maximum of 2) and the units of “Sequence Depth” are Sequenced Fragments/</a:t>
            </a:r>
            <a:r>
              <a:rPr lang="en-US" sz="1400" dirty="0" err="1"/>
              <a:t>bp</a:t>
            </a:r>
            <a:r>
              <a:rPr lang="en-US" sz="1400" dirty="0"/>
              <a:t> (SFB).  The number printed in the plot area  is the number of assembled sequences with normalized Bit Score above 1.5.  A BS of 1.5 is an arbitrary threshold, yet represents long </a:t>
            </a:r>
            <a:r>
              <a:rPr lang="en-US" sz="1400" dirty="0" smtClean="0"/>
              <a:t>and </a:t>
            </a:r>
            <a:r>
              <a:rPr lang="en-US" sz="1400" dirty="0"/>
              <a:t>accurate </a:t>
            </a:r>
            <a:r>
              <a:rPr lang="en-US" sz="1400" dirty="0" smtClean="0"/>
              <a:t>assemblies, and </a:t>
            </a:r>
            <a:r>
              <a:rPr lang="en-US" sz="1400" dirty="0"/>
              <a:t>is used to illustrate the difference in the high density region seen in most plots near BS 1.75-2</a:t>
            </a:r>
            <a:r>
              <a:rPr lang="en-US" sz="1400" dirty="0" smtClean="0"/>
              <a:t>.  For instance, a transcript that was reconstructed to 75% of the reference cDNA length with no errors would result in an alignment with a BS of 1.5.  Since the rate of base call errors, alignment gaps and Type II errors are very low, the BS reports primarily alignment length.</a:t>
            </a:r>
          </a:p>
          <a:p>
            <a:pPr marL="0" indent="0">
              <a:buNone/>
            </a:pPr>
            <a:endParaRPr lang="en-US" sz="1400" dirty="0"/>
          </a:p>
          <a:p>
            <a:pPr marL="0" indent="0">
              <a:buNone/>
            </a:pPr>
            <a:r>
              <a:rPr lang="en-US" sz="1400" dirty="0"/>
              <a:t> </a:t>
            </a:r>
          </a:p>
          <a:p>
            <a:pPr marL="0" indent="0">
              <a:buNone/>
            </a:pP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560500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ppendix_scatter_BR1_primary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9144001" cy="3663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1712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"/>
            <a:ext cx="7315199" cy="5486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87445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ppendix_scatter_BR2_primary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9192180" cy="3683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99721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ppendix_scatter_BR2_postproc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-1"/>
            <a:ext cx="9144000" cy="3661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15343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ppendix_scatter_BR12_primary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9160483" cy="367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23423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ppendix_scatter_BR12_postproc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9144000" cy="3663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93692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ppendix_scatter_NORM_primary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457"/>
            <a:ext cx="5460999" cy="54561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42817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ppendix_scatter_NORM_postproc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457"/>
            <a:ext cx="5503531" cy="54986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3553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60</Words>
  <Application>Microsoft Macintosh PowerPoint</Application>
  <PresentationFormat>On-screen Show (4:3)</PresentationFormat>
  <Paragraphs>4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3 Fil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en Honaas</dc:creator>
  <cp:lastModifiedBy>Loren Honaas</cp:lastModifiedBy>
  <cp:revision>7</cp:revision>
  <dcterms:created xsi:type="dcterms:W3CDTF">2013-04-07T19:38:25Z</dcterms:created>
  <dcterms:modified xsi:type="dcterms:W3CDTF">2015-12-15T21:49:22Z</dcterms:modified>
</cp:coreProperties>
</file>